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106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13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14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412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106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899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874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990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309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062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703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96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59"/>
          <a:stretch/>
        </p:blipFill>
        <p:spPr>
          <a:xfrm>
            <a:off x="4729942" y="1180404"/>
            <a:ext cx="3075563" cy="5758913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714320" y="622999"/>
            <a:ext cx="93440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 Fig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kt1 knockdown in combination with rapamycin promotes the radiosensitizing effect of rapamycin and leads to an increased frequency of non-repaired DNA-DSBs in MDA-MB-231 cell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58963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htoul04a</dc:creator>
  <cp:lastModifiedBy>MT</cp:lastModifiedBy>
  <cp:revision>17</cp:revision>
  <dcterms:created xsi:type="dcterms:W3CDTF">2015-08-27T14:11:55Z</dcterms:created>
  <dcterms:modified xsi:type="dcterms:W3CDTF">2016-04-21T10:30:33Z</dcterms:modified>
</cp:coreProperties>
</file>